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3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1893"/>
    <a:srgbClr val="942093"/>
    <a:srgbClr val="9437FF"/>
    <a:srgbClr val="FF9300"/>
    <a:srgbClr val="929292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404"/>
    <p:restoredTop sz="96310"/>
  </p:normalViewPr>
  <p:slideViewPr>
    <p:cSldViewPr snapToGrid="0">
      <p:cViewPr>
        <p:scale>
          <a:sx n="111" d="100"/>
          <a:sy n="111" d="100"/>
        </p:scale>
        <p:origin x="468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6A4D8E-4468-8940-8495-075939C632A2}" type="datetimeFigureOut">
              <a:rPr lang="en-US" smtClean="0"/>
              <a:t>9/16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EE1239-6483-EE4F-A3E6-E515071B15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7593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026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356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175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5280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62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317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9112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717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747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312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499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078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20" Type="http://schemas.openxmlformats.org/officeDocument/2006/relationships/image" Target="../media/image1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19" Type="http://schemas.openxmlformats.org/officeDocument/2006/relationships/image" Target="../media/image18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3E3D88A-C8E8-B3B7-B969-21159834938A}"/>
              </a:ext>
            </a:extLst>
          </p:cNvPr>
          <p:cNvSpPr txBox="1"/>
          <p:nvPr/>
        </p:nvSpPr>
        <p:spPr>
          <a:xfrm>
            <a:off x="0" y="-21905"/>
            <a:ext cx="643364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 S6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21C3923-3002-2513-1495-4277D7388C8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02" t="423" r="-202" b="24035"/>
          <a:stretch/>
        </p:blipFill>
        <p:spPr>
          <a:xfrm>
            <a:off x="2564164" y="3709032"/>
            <a:ext cx="772708" cy="101679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E7905F0-5D0E-0CB2-601D-4EE722E36E9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9064" t="34779" r="15714" b="39815"/>
          <a:stretch/>
        </p:blipFill>
        <p:spPr>
          <a:xfrm rot="5400000">
            <a:off x="5807616" y="4080817"/>
            <a:ext cx="433835" cy="27389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773C4BA-E23C-03E2-70A9-DB9303EA656C}"/>
              </a:ext>
            </a:extLst>
          </p:cNvPr>
          <p:cNvSpPr txBox="1"/>
          <p:nvPr/>
        </p:nvSpPr>
        <p:spPr>
          <a:xfrm>
            <a:off x="5789732" y="3771116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ace:</a:t>
            </a:r>
            <a:endParaRPr lang="en-US" sz="10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07F68F8-5CCD-79CD-464C-07478C9E22B0}"/>
              </a:ext>
            </a:extLst>
          </p:cNvPr>
          <p:cNvSpPr txBox="1"/>
          <p:nvPr/>
        </p:nvSpPr>
        <p:spPr>
          <a:xfrm>
            <a:off x="6123156" y="3992220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hite</a:t>
            </a:r>
            <a:endParaRPr lang="en-US" sz="10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05416C4-F2E6-9641-CAC6-B8C530D8DBE5}"/>
              </a:ext>
            </a:extLst>
          </p:cNvPr>
          <p:cNvSpPr txBox="1"/>
          <p:nvPr/>
        </p:nvSpPr>
        <p:spPr>
          <a:xfrm>
            <a:off x="6139858" y="4240795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lack</a:t>
            </a:r>
            <a:endParaRPr lang="en-US" sz="1000" dirty="0">
              <a:latin typeface="Symbol" pitchFamily="2" charset="2"/>
              <a:cs typeface="Arial" panose="020B0604020202020204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5CB72ED-E8D7-D7A0-ADF6-21989226E82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336" b="22852"/>
          <a:stretch/>
        </p:blipFill>
        <p:spPr>
          <a:xfrm>
            <a:off x="4268584" y="3587715"/>
            <a:ext cx="1035397" cy="116072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3636D8B-517D-AD8F-9D0F-145A2BECC43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3038" b="23974"/>
          <a:stretch/>
        </p:blipFill>
        <p:spPr>
          <a:xfrm>
            <a:off x="3442095" y="3670070"/>
            <a:ext cx="915458" cy="106118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5BFB025-5218-F73D-C2FC-82C6EB8D5F12}"/>
              </a:ext>
            </a:extLst>
          </p:cNvPr>
          <p:cNvSpPr txBox="1"/>
          <p:nvPr/>
        </p:nvSpPr>
        <p:spPr>
          <a:xfrm>
            <a:off x="2728328" y="3537707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=0.30</a:t>
            </a:r>
            <a:endParaRPr lang="en-US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59A6E41-76AB-B845-B2FB-B065CAAC7313}"/>
              </a:ext>
            </a:extLst>
          </p:cNvPr>
          <p:cNvSpPr txBox="1"/>
          <p:nvPr/>
        </p:nvSpPr>
        <p:spPr>
          <a:xfrm>
            <a:off x="4688801" y="3537705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=0.05</a:t>
            </a:r>
            <a:endParaRPr lang="en-US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F1C84BE-03C0-8137-CA90-77B3EB6994F9}"/>
              </a:ext>
            </a:extLst>
          </p:cNvPr>
          <p:cNvSpPr txBox="1"/>
          <p:nvPr/>
        </p:nvSpPr>
        <p:spPr>
          <a:xfrm>
            <a:off x="2762448" y="3365254"/>
            <a:ext cx="4395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P</a:t>
            </a:r>
            <a:endParaRPr lang="en-US" sz="10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4418826-9F8E-D8CC-9937-D0E6599FDD73}"/>
              </a:ext>
            </a:extLst>
          </p:cNvPr>
          <p:cNvSpPr txBox="1"/>
          <p:nvPr/>
        </p:nvSpPr>
        <p:spPr>
          <a:xfrm>
            <a:off x="3523571" y="3365254"/>
            <a:ext cx="8771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2024 IgG</a:t>
            </a:r>
            <a:endParaRPr lang="en-US" sz="10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6D8C776-3581-450D-4D07-2AA7E40D5283}"/>
              </a:ext>
            </a:extLst>
          </p:cNvPr>
          <p:cNvSpPr txBox="1"/>
          <p:nvPr/>
        </p:nvSpPr>
        <p:spPr>
          <a:xfrm>
            <a:off x="4394670" y="3365254"/>
            <a:ext cx="1236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2024 IgG + IgM</a:t>
            </a:r>
            <a:endParaRPr lang="en-US" sz="10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D9579AB-7D60-6299-ED5C-B72BF11F3958}"/>
              </a:ext>
            </a:extLst>
          </p:cNvPr>
          <p:cNvSpPr txBox="1"/>
          <p:nvPr/>
        </p:nvSpPr>
        <p:spPr>
          <a:xfrm>
            <a:off x="3700870" y="3537707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=0.11</a:t>
            </a:r>
            <a:endParaRPr lang="en-US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6DF2E42-4501-EAEE-90AB-B547FD4AE474}"/>
              </a:ext>
            </a:extLst>
          </p:cNvPr>
          <p:cNvSpPr txBox="1"/>
          <p:nvPr/>
        </p:nvSpPr>
        <p:spPr>
          <a:xfrm>
            <a:off x="2197917" y="3280437"/>
            <a:ext cx="30649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/>
              <a:t>C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75C6C1C4-D484-E71B-A757-0F07DC960CB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2287" b="24431"/>
          <a:stretch/>
        </p:blipFill>
        <p:spPr>
          <a:xfrm>
            <a:off x="2579797" y="5127743"/>
            <a:ext cx="771482" cy="984802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59F66345-0DCC-96F9-9F83-88D6A725E23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2646" b="26424"/>
          <a:stretch/>
        </p:blipFill>
        <p:spPr>
          <a:xfrm>
            <a:off x="3432971" y="5105539"/>
            <a:ext cx="835613" cy="984802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429177B2-02CF-87F1-0C52-4E5C1B528648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2751" b="25148"/>
          <a:stretch/>
        </p:blipFill>
        <p:spPr>
          <a:xfrm>
            <a:off x="4346888" y="5111733"/>
            <a:ext cx="822041" cy="984802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FEA6A220-8B78-1AF0-F871-1B2D56E58A65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2813" b="25180"/>
          <a:stretch/>
        </p:blipFill>
        <p:spPr>
          <a:xfrm>
            <a:off x="5196609" y="5093418"/>
            <a:ext cx="823130" cy="984802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74C2B960-1838-AD3F-FE56-B583F744CA24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41" b="24530"/>
          <a:stretch/>
        </p:blipFill>
        <p:spPr>
          <a:xfrm>
            <a:off x="6036570" y="5030788"/>
            <a:ext cx="832261" cy="1043054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4E7E644B-1942-7A26-DAC2-2D47DDBDDBE5}"/>
              </a:ext>
            </a:extLst>
          </p:cNvPr>
          <p:cNvSpPr txBox="1"/>
          <p:nvPr/>
        </p:nvSpPr>
        <p:spPr>
          <a:xfrm>
            <a:off x="2779838" y="4922386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=0.3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AD49AE0-838D-1514-E4F0-390B9060AFB1}"/>
              </a:ext>
            </a:extLst>
          </p:cNvPr>
          <p:cNvSpPr txBox="1"/>
          <p:nvPr/>
        </p:nvSpPr>
        <p:spPr>
          <a:xfrm>
            <a:off x="3700791" y="4922386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=0.9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955C892-3F5A-E431-529D-D046031CC80E}"/>
              </a:ext>
            </a:extLst>
          </p:cNvPr>
          <p:cNvSpPr txBox="1"/>
          <p:nvPr/>
        </p:nvSpPr>
        <p:spPr>
          <a:xfrm>
            <a:off x="4579083" y="4922386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=0.49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9ACC14B-1854-C639-708D-D0961EFBBCB3}"/>
              </a:ext>
            </a:extLst>
          </p:cNvPr>
          <p:cNvSpPr txBox="1"/>
          <p:nvPr/>
        </p:nvSpPr>
        <p:spPr>
          <a:xfrm>
            <a:off x="5475894" y="4922386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=0.56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EAB133E-12DB-86A5-F0B3-DAD8CB0DBB64}"/>
              </a:ext>
            </a:extLst>
          </p:cNvPr>
          <p:cNvSpPr txBox="1"/>
          <p:nvPr/>
        </p:nvSpPr>
        <p:spPr>
          <a:xfrm>
            <a:off x="6292625" y="4922386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=0.07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70A45BBF-7F4E-0295-9970-682077787ADD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10824" b="-202"/>
          <a:stretch/>
        </p:blipFill>
        <p:spPr>
          <a:xfrm>
            <a:off x="2606912" y="6391976"/>
            <a:ext cx="905275" cy="1033272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DDE879B3-E8C8-5E85-8928-A1692B3C192A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t="16005" b="783"/>
          <a:stretch/>
        </p:blipFill>
        <p:spPr>
          <a:xfrm>
            <a:off x="3469475" y="6391976"/>
            <a:ext cx="972362" cy="1033272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0F119E74-DFA1-3273-76E3-0721875F0739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t="14108" b="-662"/>
          <a:stretch/>
        </p:blipFill>
        <p:spPr>
          <a:xfrm>
            <a:off x="4394670" y="6391976"/>
            <a:ext cx="783226" cy="1033272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C03D0F0B-3613-5E25-FAED-A445A2CBA5A4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t="14728" b="-527"/>
          <a:stretch/>
        </p:blipFill>
        <p:spPr>
          <a:xfrm>
            <a:off x="5192869" y="6391976"/>
            <a:ext cx="930287" cy="1033272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31ADEAF9-24C5-79CC-9444-505456C0E05C}"/>
              </a:ext>
            </a:extLst>
          </p:cNvPr>
          <p:cNvSpPr txBox="1"/>
          <p:nvPr/>
        </p:nvSpPr>
        <p:spPr>
          <a:xfrm>
            <a:off x="2751276" y="6333028"/>
            <a:ext cx="6046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=0.034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0F7C34B-B551-4A34-E0B6-C45CF25C53A0}"/>
              </a:ext>
            </a:extLst>
          </p:cNvPr>
          <p:cNvSpPr txBox="1"/>
          <p:nvPr/>
        </p:nvSpPr>
        <p:spPr>
          <a:xfrm>
            <a:off x="3694263" y="6333028"/>
            <a:ext cx="6046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=0.015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FB257C3-A07A-C1C2-2A21-AAE63FC62558}"/>
              </a:ext>
            </a:extLst>
          </p:cNvPr>
          <p:cNvSpPr txBox="1"/>
          <p:nvPr/>
        </p:nvSpPr>
        <p:spPr>
          <a:xfrm>
            <a:off x="5430573" y="6333028"/>
            <a:ext cx="6046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=0.003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2931DA0-8879-74CE-A52E-668DEF0CBB4E}"/>
              </a:ext>
            </a:extLst>
          </p:cNvPr>
          <p:cNvSpPr txBox="1"/>
          <p:nvPr/>
        </p:nvSpPr>
        <p:spPr>
          <a:xfrm>
            <a:off x="4586537" y="6333028"/>
            <a:ext cx="6046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=0.036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B0A51F7-FF79-1C17-8E85-35C29FFE41D8}"/>
              </a:ext>
            </a:extLst>
          </p:cNvPr>
          <p:cNvSpPr txBox="1"/>
          <p:nvPr/>
        </p:nvSpPr>
        <p:spPr>
          <a:xfrm>
            <a:off x="2784097" y="4718964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o Ag</a:t>
            </a:r>
            <a:endParaRPr lang="en-US" sz="10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D56A163-6846-B112-2427-81AD6D795871}"/>
              </a:ext>
            </a:extLst>
          </p:cNvPr>
          <p:cNvSpPr txBox="1"/>
          <p:nvPr/>
        </p:nvSpPr>
        <p:spPr>
          <a:xfrm>
            <a:off x="3714786" y="4718964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HA</a:t>
            </a:r>
            <a:endParaRPr lang="en-US" sz="10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223D7D6-3CAA-6150-7C60-36DA1E91038B}"/>
              </a:ext>
            </a:extLst>
          </p:cNvPr>
          <p:cNvSpPr txBox="1"/>
          <p:nvPr/>
        </p:nvSpPr>
        <p:spPr>
          <a:xfrm>
            <a:off x="4508846" y="4718964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Fluzone</a:t>
            </a:r>
            <a:endParaRPr lang="en-US" sz="10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0B3B013-D895-B56A-DEAC-15EEAAE0A9AF}"/>
              </a:ext>
            </a:extLst>
          </p:cNvPr>
          <p:cNvSpPr txBox="1"/>
          <p:nvPr/>
        </p:nvSpPr>
        <p:spPr>
          <a:xfrm>
            <a:off x="6244264" y="4718964"/>
            <a:ext cx="6367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2024</a:t>
            </a:r>
            <a:endParaRPr lang="en-US" sz="10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E78DE35-4D69-4AB8-B955-D1067DEDB2CB}"/>
              </a:ext>
            </a:extLst>
          </p:cNvPr>
          <p:cNvSpPr txBox="1"/>
          <p:nvPr/>
        </p:nvSpPr>
        <p:spPr>
          <a:xfrm>
            <a:off x="2685646" y="6155033"/>
            <a:ext cx="8467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4 T cells</a:t>
            </a:r>
            <a:endParaRPr lang="en-US" sz="10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425FA9A-8745-AC45-0B69-F72706AE4472}"/>
              </a:ext>
            </a:extLst>
          </p:cNvPr>
          <p:cNvSpPr txBox="1"/>
          <p:nvPr/>
        </p:nvSpPr>
        <p:spPr>
          <a:xfrm>
            <a:off x="3653875" y="6155033"/>
            <a:ext cx="8467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8 T cells</a:t>
            </a:r>
            <a:endParaRPr lang="en-US" sz="10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7AA246D-9981-A1EB-F663-40F2B86EBE4E}"/>
              </a:ext>
            </a:extLst>
          </p:cNvPr>
          <p:cNvSpPr txBox="1"/>
          <p:nvPr/>
        </p:nvSpPr>
        <p:spPr>
          <a:xfrm>
            <a:off x="4634517" y="6155033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 cells</a:t>
            </a:r>
            <a:endParaRPr lang="en-US" sz="10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42FFA3B-643E-BF6F-2413-F8A3131717A9}"/>
              </a:ext>
            </a:extLst>
          </p:cNvPr>
          <p:cNvSpPr txBox="1"/>
          <p:nvPr/>
        </p:nvSpPr>
        <p:spPr>
          <a:xfrm>
            <a:off x="5341868" y="6155033"/>
            <a:ext cx="8018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  <a:endParaRPr lang="en-US" sz="10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814AD74-D5A2-72D3-998C-4AA73C214961}"/>
              </a:ext>
            </a:extLst>
          </p:cNvPr>
          <p:cNvSpPr txBox="1"/>
          <p:nvPr/>
        </p:nvSpPr>
        <p:spPr>
          <a:xfrm rot="16200000">
            <a:off x="1867650" y="5438275"/>
            <a:ext cx="12089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FU per 3e10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cells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4773B408-B696-3E84-E071-820A80D9000D}"/>
              </a:ext>
            </a:extLst>
          </p:cNvPr>
          <p:cNvSpPr txBox="1"/>
          <p:nvPr/>
        </p:nvSpPr>
        <p:spPr>
          <a:xfrm rot="16200000">
            <a:off x="2147374" y="6763313"/>
            <a:ext cx="64953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%CD45+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5640EF6-FEE3-9966-E55D-926264D8E88E}"/>
              </a:ext>
            </a:extLst>
          </p:cNvPr>
          <p:cNvSpPr txBox="1"/>
          <p:nvPr/>
        </p:nvSpPr>
        <p:spPr>
          <a:xfrm>
            <a:off x="3228973" y="3280437"/>
            <a:ext cx="236261" cy="3057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D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5094FAB-BEB6-935C-09E3-48C04A0D3BD5}"/>
              </a:ext>
            </a:extLst>
          </p:cNvPr>
          <p:cNvSpPr txBox="1"/>
          <p:nvPr/>
        </p:nvSpPr>
        <p:spPr>
          <a:xfrm rot="16200000">
            <a:off x="1877307" y="4102346"/>
            <a:ext cx="12089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FU per 3e10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cells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868842D2-80F7-32C7-628D-C609BD280634}"/>
              </a:ext>
            </a:extLst>
          </p:cNvPr>
          <p:cNvSpPr txBox="1"/>
          <p:nvPr/>
        </p:nvSpPr>
        <p:spPr>
          <a:xfrm rot="16200000">
            <a:off x="2935715" y="4141821"/>
            <a:ext cx="8579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ntibody titer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15220549-5D36-A6C7-D604-27BE79AF6455}"/>
              </a:ext>
            </a:extLst>
          </p:cNvPr>
          <p:cNvSpPr txBox="1"/>
          <p:nvPr/>
        </p:nvSpPr>
        <p:spPr>
          <a:xfrm>
            <a:off x="2175038" y="4724192"/>
            <a:ext cx="236261" cy="3057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E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C8B6F347-EF68-8D50-9128-2CC0863F3957}"/>
              </a:ext>
            </a:extLst>
          </p:cNvPr>
          <p:cNvSpPr txBox="1"/>
          <p:nvPr/>
        </p:nvSpPr>
        <p:spPr>
          <a:xfrm>
            <a:off x="0" y="187811"/>
            <a:ext cx="29206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/>
              <a:t>A</a:t>
            </a:r>
          </a:p>
        </p:txBody>
      </p:sp>
      <p:pic>
        <p:nvPicPr>
          <p:cNvPr id="81" name="Picture 80">
            <a:extLst>
              <a:ext uri="{FF2B5EF4-FFF2-40B4-BE49-F238E27FC236}">
                <a16:creationId xmlns:a16="http://schemas.microsoft.com/office/drawing/2014/main" id="{D0A91D2F-381B-EA70-1889-594717C92B86}"/>
              </a:ext>
            </a:extLst>
          </p:cNvPr>
          <p:cNvPicPr>
            <a:picLocks noChangeAspect="1"/>
          </p:cNvPicPr>
          <p:nvPr/>
        </p:nvPicPr>
        <p:blipFill>
          <a:blip r:embed="rId15"/>
          <a:srcRect/>
          <a:stretch/>
        </p:blipFill>
        <p:spPr>
          <a:xfrm>
            <a:off x="29238" y="445527"/>
            <a:ext cx="2055676" cy="2532888"/>
          </a:xfrm>
          <a:prstGeom prst="rect">
            <a:avLst/>
          </a:prstGeom>
        </p:spPr>
      </p:pic>
      <p:sp>
        <p:nvSpPr>
          <p:cNvPr id="82" name="TextBox 81">
            <a:extLst>
              <a:ext uri="{FF2B5EF4-FFF2-40B4-BE49-F238E27FC236}">
                <a16:creationId xmlns:a16="http://schemas.microsoft.com/office/drawing/2014/main" id="{31076959-9D67-705C-C152-3EC6EA329026}"/>
              </a:ext>
            </a:extLst>
          </p:cNvPr>
          <p:cNvSpPr txBox="1"/>
          <p:nvPr/>
        </p:nvSpPr>
        <p:spPr>
          <a:xfrm>
            <a:off x="2847260" y="3003109"/>
            <a:ext cx="17147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old mock control</a:t>
            </a: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F77FB8B7-40D8-5F55-C826-3AD2717FD804}"/>
              </a:ext>
            </a:extLst>
          </p:cNvPr>
          <p:cNvSpPr/>
          <p:nvPr/>
        </p:nvSpPr>
        <p:spPr>
          <a:xfrm>
            <a:off x="1591238" y="602542"/>
            <a:ext cx="590444" cy="4265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0" name="Picture 89">
            <a:extLst>
              <a:ext uri="{FF2B5EF4-FFF2-40B4-BE49-F238E27FC236}">
                <a16:creationId xmlns:a16="http://schemas.microsoft.com/office/drawing/2014/main" id="{E7172E0F-C128-025F-4FA2-EC99468B40EE}"/>
              </a:ext>
            </a:extLst>
          </p:cNvPr>
          <p:cNvPicPr>
            <a:picLocks noChangeAspect="1"/>
          </p:cNvPicPr>
          <p:nvPr/>
        </p:nvPicPr>
        <p:blipFill>
          <a:blip r:embed="rId16"/>
          <a:srcRect l="19846"/>
          <a:stretch/>
        </p:blipFill>
        <p:spPr>
          <a:xfrm>
            <a:off x="3688867" y="446031"/>
            <a:ext cx="1647697" cy="2532888"/>
          </a:xfrm>
          <a:prstGeom prst="rect">
            <a:avLst/>
          </a:prstGeom>
        </p:spPr>
      </p:pic>
      <p:pic>
        <p:nvPicPr>
          <p:cNvPr id="92" name="Picture 91">
            <a:extLst>
              <a:ext uri="{FF2B5EF4-FFF2-40B4-BE49-F238E27FC236}">
                <a16:creationId xmlns:a16="http://schemas.microsoft.com/office/drawing/2014/main" id="{CA00C474-30D3-1C49-B985-34F3362E6535}"/>
              </a:ext>
            </a:extLst>
          </p:cNvPr>
          <p:cNvPicPr>
            <a:picLocks noChangeAspect="1"/>
          </p:cNvPicPr>
          <p:nvPr/>
        </p:nvPicPr>
        <p:blipFill>
          <a:blip r:embed="rId17"/>
          <a:srcRect l="19846"/>
          <a:stretch/>
        </p:blipFill>
        <p:spPr>
          <a:xfrm>
            <a:off x="5328644" y="446031"/>
            <a:ext cx="1647697" cy="2532888"/>
          </a:xfrm>
          <a:prstGeom prst="rect">
            <a:avLst/>
          </a:prstGeom>
        </p:spPr>
      </p:pic>
      <p:pic>
        <p:nvPicPr>
          <p:cNvPr id="86" name="Picture 85">
            <a:extLst>
              <a:ext uri="{FF2B5EF4-FFF2-40B4-BE49-F238E27FC236}">
                <a16:creationId xmlns:a16="http://schemas.microsoft.com/office/drawing/2014/main" id="{3B5A98EE-6272-F0ED-7032-5859BCCD3316}"/>
              </a:ext>
            </a:extLst>
          </p:cNvPr>
          <p:cNvPicPr>
            <a:picLocks noChangeAspect="1"/>
          </p:cNvPicPr>
          <p:nvPr/>
        </p:nvPicPr>
        <p:blipFill>
          <a:blip r:embed="rId18"/>
          <a:srcRect l="19847"/>
          <a:stretch/>
        </p:blipFill>
        <p:spPr>
          <a:xfrm>
            <a:off x="2091737" y="449092"/>
            <a:ext cx="1647697" cy="2532888"/>
          </a:xfrm>
          <a:prstGeom prst="rect">
            <a:avLst/>
          </a:prstGeom>
        </p:spPr>
      </p:pic>
      <p:sp>
        <p:nvSpPr>
          <p:cNvPr id="96" name="TextBox 95">
            <a:extLst>
              <a:ext uri="{FF2B5EF4-FFF2-40B4-BE49-F238E27FC236}">
                <a16:creationId xmlns:a16="http://schemas.microsoft.com/office/drawing/2014/main" id="{699B65E4-1A3C-436E-B129-B2B62E6807E8}"/>
              </a:ext>
            </a:extLst>
          </p:cNvPr>
          <p:cNvSpPr txBox="1"/>
          <p:nvPr/>
        </p:nvSpPr>
        <p:spPr>
          <a:xfrm>
            <a:off x="1909038" y="260074"/>
            <a:ext cx="18119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PS (TLR4)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D045EFC7-D941-AAD8-BA71-C85F013222C7}"/>
              </a:ext>
            </a:extLst>
          </p:cNvPr>
          <p:cNvSpPr txBox="1"/>
          <p:nvPr/>
        </p:nvSpPr>
        <p:spPr>
          <a:xfrm>
            <a:off x="210526" y="260074"/>
            <a:ext cx="18119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M3CSK4 (TLR1/2)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62DD11E6-A8DC-CF56-1E0F-DBABC1AEA001}"/>
              </a:ext>
            </a:extLst>
          </p:cNvPr>
          <p:cNvSpPr txBox="1"/>
          <p:nvPr/>
        </p:nvSpPr>
        <p:spPr>
          <a:xfrm>
            <a:off x="5979380" y="3145704"/>
            <a:ext cx="4331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=14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7DAD50EF-E9D8-2519-0488-B818FF7A581F}"/>
              </a:ext>
            </a:extLst>
          </p:cNvPr>
          <p:cNvSpPr txBox="1"/>
          <p:nvPr/>
        </p:nvSpPr>
        <p:spPr>
          <a:xfrm>
            <a:off x="5433142" y="3147496"/>
            <a:ext cx="4331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=14</a:t>
            </a:r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5A2715CF-3C04-8C95-C275-74F575CFEB4F}"/>
              </a:ext>
            </a:extLst>
          </p:cNvPr>
          <p:cNvSpPr/>
          <p:nvPr/>
        </p:nvSpPr>
        <p:spPr>
          <a:xfrm>
            <a:off x="5185957" y="3020860"/>
            <a:ext cx="1374994" cy="3592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42514593-0F21-E184-DF02-3C4F1357FBDD}"/>
              </a:ext>
            </a:extLst>
          </p:cNvPr>
          <p:cNvSpPr/>
          <p:nvPr/>
        </p:nvSpPr>
        <p:spPr>
          <a:xfrm>
            <a:off x="5453686" y="3057486"/>
            <a:ext cx="419768" cy="14605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F3731484-EC35-6F89-111C-AE489CA01AC8}"/>
              </a:ext>
            </a:extLst>
          </p:cNvPr>
          <p:cNvSpPr/>
          <p:nvPr/>
        </p:nvSpPr>
        <p:spPr>
          <a:xfrm>
            <a:off x="6019086" y="3049640"/>
            <a:ext cx="486311" cy="14605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DEB7246E-801E-E60D-C46F-01C952B97B37}"/>
              </a:ext>
            </a:extLst>
          </p:cNvPr>
          <p:cNvSpPr txBox="1"/>
          <p:nvPr/>
        </p:nvSpPr>
        <p:spPr>
          <a:xfrm>
            <a:off x="5386269" y="3010042"/>
            <a:ext cx="7106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White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D6D2BDB1-53CD-9139-0462-3B994928BA32}"/>
              </a:ext>
            </a:extLst>
          </p:cNvPr>
          <p:cNvSpPr txBox="1"/>
          <p:nvPr/>
        </p:nvSpPr>
        <p:spPr>
          <a:xfrm>
            <a:off x="5956715" y="3009502"/>
            <a:ext cx="7106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Black</a:t>
            </a:r>
          </a:p>
        </p:txBody>
      </p:sp>
      <p:pic>
        <p:nvPicPr>
          <p:cNvPr id="105" name="Picture 104">
            <a:extLst>
              <a:ext uri="{FF2B5EF4-FFF2-40B4-BE49-F238E27FC236}">
                <a16:creationId xmlns:a16="http://schemas.microsoft.com/office/drawing/2014/main" id="{28D7D312-E4C2-1CCE-41C0-34A1087C699F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l="79103" t="4833" r="17661" b="83972"/>
          <a:stretch/>
        </p:blipFill>
        <p:spPr>
          <a:xfrm>
            <a:off x="5819498" y="3048221"/>
            <a:ext cx="202052" cy="253500"/>
          </a:xfrm>
          <a:prstGeom prst="rect">
            <a:avLst/>
          </a:prstGeom>
        </p:spPr>
      </p:pic>
      <p:pic>
        <p:nvPicPr>
          <p:cNvPr id="106" name="Picture 105">
            <a:extLst>
              <a:ext uri="{FF2B5EF4-FFF2-40B4-BE49-F238E27FC236}">
                <a16:creationId xmlns:a16="http://schemas.microsoft.com/office/drawing/2014/main" id="{BA16F146-53D9-F571-BCDC-642455163447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l="65416" r="31772" b="83224"/>
          <a:stretch/>
        </p:blipFill>
        <p:spPr>
          <a:xfrm>
            <a:off x="5282517" y="2946773"/>
            <a:ext cx="169228" cy="366226"/>
          </a:xfrm>
          <a:prstGeom prst="rect">
            <a:avLst/>
          </a:prstGeom>
        </p:spPr>
      </p:pic>
      <p:sp>
        <p:nvSpPr>
          <p:cNvPr id="107" name="TextBox 106">
            <a:extLst>
              <a:ext uri="{FF2B5EF4-FFF2-40B4-BE49-F238E27FC236}">
                <a16:creationId xmlns:a16="http://schemas.microsoft.com/office/drawing/2014/main" id="{FA280CDE-903B-09ED-A3D0-0FFC91DD98EB}"/>
              </a:ext>
            </a:extLst>
          </p:cNvPr>
          <p:cNvSpPr txBox="1"/>
          <p:nvPr/>
        </p:nvSpPr>
        <p:spPr>
          <a:xfrm>
            <a:off x="3302244" y="260074"/>
            <a:ext cx="20284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Lyove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HMW Poly I:C (MDA5)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FF9F009A-562A-CACB-9BCA-DD571F4F7998}"/>
              </a:ext>
            </a:extLst>
          </p:cNvPr>
          <p:cNvSpPr txBox="1"/>
          <p:nvPr/>
        </p:nvSpPr>
        <p:spPr>
          <a:xfrm>
            <a:off x="5174321" y="260074"/>
            <a:ext cx="18119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3/28 (T cell stim)</a:t>
            </a:r>
          </a:p>
        </p:txBody>
      </p:sp>
      <p:pic>
        <p:nvPicPr>
          <p:cNvPr id="110" name="Picture 109">
            <a:extLst>
              <a:ext uri="{FF2B5EF4-FFF2-40B4-BE49-F238E27FC236}">
                <a16:creationId xmlns:a16="http://schemas.microsoft.com/office/drawing/2014/main" id="{3D400DFD-1E49-8E18-5252-97E93A73AF55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77258" y="4219497"/>
            <a:ext cx="2026512" cy="3100563"/>
          </a:xfrm>
          <a:prstGeom prst="rect">
            <a:avLst/>
          </a:prstGeom>
        </p:spPr>
      </p:pic>
      <p:sp>
        <p:nvSpPr>
          <p:cNvPr id="111" name="TextBox 110">
            <a:extLst>
              <a:ext uri="{FF2B5EF4-FFF2-40B4-BE49-F238E27FC236}">
                <a16:creationId xmlns:a16="http://schemas.microsoft.com/office/drawing/2014/main" id="{72E2BBAC-F9B0-E35C-7A8A-FC7C6B1D4E31}"/>
              </a:ext>
            </a:extLst>
          </p:cNvPr>
          <p:cNvSpPr txBox="1"/>
          <p:nvPr/>
        </p:nvSpPr>
        <p:spPr>
          <a:xfrm>
            <a:off x="168618" y="4045447"/>
            <a:ext cx="18119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Log(p-value)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473F53BA-318C-BE71-93EF-BF814B197891}"/>
              </a:ext>
            </a:extLst>
          </p:cNvPr>
          <p:cNvSpPr txBox="1"/>
          <p:nvPr/>
        </p:nvSpPr>
        <p:spPr>
          <a:xfrm>
            <a:off x="0" y="3280437"/>
            <a:ext cx="29206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/>
              <a:t>B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6FE714C7-4A0F-9F74-815D-10FA5042D699}"/>
              </a:ext>
            </a:extLst>
          </p:cNvPr>
          <p:cNvSpPr txBox="1"/>
          <p:nvPr/>
        </p:nvSpPr>
        <p:spPr>
          <a:xfrm>
            <a:off x="2172906" y="6085303"/>
            <a:ext cx="236261" cy="3057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4D39FE48-78F1-DED5-6419-69473FD8EFF1}"/>
              </a:ext>
            </a:extLst>
          </p:cNvPr>
          <p:cNvSpPr txBox="1"/>
          <p:nvPr/>
        </p:nvSpPr>
        <p:spPr>
          <a:xfrm>
            <a:off x="5427758" y="4718964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EFT</a:t>
            </a:r>
            <a:endParaRPr lang="en-US" sz="10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960E1E5-22B2-61B3-811A-CB5535BAC740}"/>
              </a:ext>
            </a:extLst>
          </p:cNvPr>
          <p:cNvSpPr txBox="1"/>
          <p:nvPr/>
        </p:nvSpPr>
        <p:spPr>
          <a:xfrm>
            <a:off x="123592" y="7385666"/>
            <a:ext cx="6683283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6 (related to Figure 4). 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Fold mock control (ctrl) cytokine induction by stimulus for the KCI validation cohort stratified by race as done for the PRIME cohort (Figure 4A, n=28; n=14 White, n=14 Black). (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Log(p-values) comparing White vs Black cytokine responses (fold mock) to each stimulus and cytokine for the KCI cohort [corresponding to data in (A)] as done for the PRIME cohort (Figure 4E). (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, D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ELISpot PAP-specific (C, n=82) and PA2024 IgG and </a:t>
            </a:r>
            <a:r>
              <a:rPr lang="en-US" sz="120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gG+IgM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D, n=89) levels stratified by race. (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ELISpot responses to indicated stimuli separated by race (PRIME cohort only: n=79 </a:t>
            </a:r>
            <a:r>
              <a:rPr lang="en-US" sz="120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luzone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n=77 CEFT, n=82 all others). (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Percentage of each indicated cell type as determined by flow cytometry of CD45+ cells separated by race (n=106; PRIME cohort only). (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, C-F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Mean -/+ SEM is shown; p-values are from unpaired t-test. 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94446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376</TotalTime>
  <Words>330</Words>
  <Application>Microsoft Macintosh PowerPoint</Application>
  <PresentationFormat>Letter Paper (8.5x11 in)</PresentationFormat>
  <Paragraphs>4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Brown</dc:creator>
  <cp:lastModifiedBy>Michael Brown</cp:lastModifiedBy>
  <cp:revision>39</cp:revision>
  <dcterms:created xsi:type="dcterms:W3CDTF">2024-05-14T01:47:53Z</dcterms:created>
  <dcterms:modified xsi:type="dcterms:W3CDTF">2024-09-16T19:44:13Z</dcterms:modified>
</cp:coreProperties>
</file>